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44EC6-D597-42AF-BAD4-555E8617C7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DBC46-1DA9-480D-AA4D-E508FBB8D8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A6949-249C-4DF1-A2AB-1F621CBBE1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E1837-95FA-421E-9F98-F4ABCE1988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0505E-1D2B-4C4B-8F47-092C4D0354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0827D-C866-479A-82F8-58D0B3AD57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856E9-C8F0-449B-99BD-7D648536F8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EB789-4537-4205-A62F-EEE1F3D48E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C413D-2EBF-4D68-BB2D-3DF569784A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81B0E-C348-4104-A390-0987404E53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114DD-02BD-47F7-8013-C6A6E85039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48C4C-96E3-4C1D-ABCD-7BA65F62AA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192E7B-25B1-482C-8A7F-80DF92FBA21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image" Target="../media/image11.png"/><Relationship Id="rId22" Type="http://schemas.openxmlformats.org/officeDocument/2006/relationships/image" Target="../media/image12.png"/><Relationship Id="rId23" Type="http://schemas.openxmlformats.org/officeDocument/2006/relationships/image" Target="../media/image13.png"/><Relationship Id="rId24" Type="http://schemas.openxmlformats.org/officeDocument/2006/relationships/image" Target="../media/image13.png"/><Relationship Id="rId25" Type="http://schemas.openxmlformats.org/officeDocument/2006/relationships/image" Target="../media/image14.png"/><Relationship Id="rId26" Type="http://schemas.openxmlformats.org/officeDocument/2006/relationships/image" Target="../media/image13.png"/><Relationship Id="rId27" Type="http://schemas.openxmlformats.org/officeDocument/2006/relationships/image" Target="../media/image13.png"/><Relationship Id="rId28" Type="http://schemas.openxmlformats.org/officeDocument/2006/relationships/image" Target="../media/image14.png"/><Relationship Id="rId29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4"/>
          <p:cNvSpPr/>
          <p:nvPr/>
        </p:nvSpPr>
        <p:spPr>
          <a:xfrm>
            <a:off x="66600" y="57240"/>
            <a:ext cx="207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9200" y="457200"/>
            <a:ext cx="39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5"/>
          <p:cNvSpPr/>
          <p:nvPr/>
        </p:nvSpPr>
        <p:spPr>
          <a:xfrm rot="16200000">
            <a:off x="338040" y="1080360"/>
            <a:ext cx="58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6"/>
          <p:cNvSpPr/>
          <p:nvPr/>
        </p:nvSpPr>
        <p:spPr>
          <a:xfrm rot="16200000">
            <a:off x="525240" y="106920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om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37"/>
          <p:cNvSpPr/>
          <p:nvPr/>
        </p:nvSpPr>
        <p:spPr>
          <a:xfrm rot="16200000">
            <a:off x="726840" y="105984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G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8"/>
          <p:cNvSpPr/>
          <p:nvPr/>
        </p:nvSpPr>
        <p:spPr>
          <a:xfrm rot="16200000">
            <a:off x="786960" y="919800"/>
            <a:ext cx="90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+EG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39"/>
          <p:cNvSpPr/>
          <p:nvPr/>
        </p:nvSpPr>
        <p:spPr>
          <a:xfrm rot="16200000">
            <a:off x="1128960" y="1055520"/>
            <a:ext cx="62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50"/>
          <p:cNvSpPr/>
          <p:nvPr/>
        </p:nvSpPr>
        <p:spPr>
          <a:xfrm>
            <a:off x="641520" y="703440"/>
            <a:ext cx="80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51"/>
          <p:cNvSpPr/>
          <p:nvPr/>
        </p:nvSpPr>
        <p:spPr>
          <a:xfrm>
            <a:off x="1638360" y="701640"/>
            <a:ext cx="804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3"/>
          <p:cNvSpPr/>
          <p:nvPr/>
        </p:nvSpPr>
        <p:spPr>
          <a:xfrm>
            <a:off x="822240" y="461880"/>
            <a:ext cx="48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4"/>
          <p:cNvSpPr/>
          <p:nvPr/>
        </p:nvSpPr>
        <p:spPr>
          <a:xfrm>
            <a:off x="1755720" y="457200"/>
            <a:ext cx="56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P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Object 81"/>
          <p:cNvGraphicFramePr/>
          <p:nvPr/>
        </p:nvGraphicFramePr>
        <p:xfrm>
          <a:off x="525600" y="1447920"/>
          <a:ext cx="1001520" cy="568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3" name="Object 8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25600" y="1447920"/>
                    <a:ext cx="1001520" cy="5680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4" name="Object 81"/>
          <p:cNvGraphicFramePr/>
          <p:nvPr/>
        </p:nvGraphicFramePr>
        <p:xfrm>
          <a:off x="523800" y="2065320"/>
          <a:ext cx="1001880" cy="228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5" name="Object 8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23800" y="2065320"/>
                    <a:ext cx="1001880" cy="2286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pSp>
        <p:nvGrpSpPr>
          <p:cNvPr id="56" name=""/>
          <p:cNvGrpSpPr/>
          <p:nvPr/>
        </p:nvGrpSpPr>
        <p:grpSpPr>
          <a:xfrm>
            <a:off x="1573200" y="1389240"/>
            <a:ext cx="1013760" cy="637560"/>
            <a:chOff x="1573200" y="1389240"/>
            <a:chExt cx="1013760" cy="637560"/>
          </a:xfrm>
        </p:grpSpPr>
        <p:grpSp>
          <p:nvGrpSpPr>
            <p:cNvPr id="57" name="Group 136"/>
            <p:cNvGrpSpPr/>
            <p:nvPr/>
          </p:nvGrpSpPr>
          <p:grpSpPr>
            <a:xfrm>
              <a:off x="1585800" y="1389240"/>
              <a:ext cx="1001160" cy="637560"/>
              <a:chOff x="1585800" y="1389240"/>
              <a:chExt cx="1001160" cy="637560"/>
            </a:xfrm>
          </p:grpSpPr>
          <p:graphicFrame>
            <p:nvGraphicFramePr>
              <p:cNvPr id="58" name="Object 82"/>
              <p:cNvGraphicFramePr/>
              <p:nvPr/>
            </p:nvGraphicFramePr>
            <p:xfrm>
              <a:off x="1585800" y="1389240"/>
              <a:ext cx="413640" cy="63504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59" name="Object 82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1585800" y="1389240"/>
                        <a:ext cx="413640" cy="635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0" name="Object 83"/>
              <p:cNvGraphicFramePr/>
              <p:nvPr/>
            </p:nvGraphicFramePr>
            <p:xfrm>
              <a:off x="1999440" y="1389240"/>
              <a:ext cx="205560" cy="63504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61" name="Object 83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1999440" y="1389240"/>
                        <a:ext cx="205560" cy="635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2" name="Object 84"/>
              <p:cNvGraphicFramePr/>
              <p:nvPr/>
            </p:nvGraphicFramePr>
            <p:xfrm>
              <a:off x="2409480" y="1391760"/>
              <a:ext cx="177480" cy="63504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63" name="Object 84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2409480" y="1391760"/>
                        <a:ext cx="177480" cy="635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4" name="Object 85"/>
              <p:cNvGraphicFramePr/>
              <p:nvPr/>
            </p:nvGraphicFramePr>
            <p:xfrm>
              <a:off x="2201760" y="1389240"/>
              <a:ext cx="207360" cy="63504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65" name="Object 85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2201760" y="1389240"/>
                        <a:ext cx="207360" cy="635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66" name=""/>
            <p:cNvSpPr/>
            <p:nvPr/>
          </p:nvSpPr>
          <p:spPr>
            <a:xfrm>
              <a:off x="1573200" y="1439640"/>
              <a:ext cx="1008000" cy="576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"/>
          <p:cNvGrpSpPr/>
          <p:nvPr/>
        </p:nvGrpSpPr>
        <p:grpSpPr>
          <a:xfrm>
            <a:off x="1568520" y="2065320"/>
            <a:ext cx="1014480" cy="236520"/>
            <a:chOff x="1568520" y="2065320"/>
            <a:chExt cx="1014480" cy="236520"/>
          </a:xfrm>
        </p:grpSpPr>
        <p:graphicFrame>
          <p:nvGraphicFramePr>
            <p:cNvPr id="68" name="Object 82"/>
            <p:cNvGraphicFramePr/>
            <p:nvPr/>
          </p:nvGraphicFramePr>
          <p:xfrm>
            <a:off x="1568520" y="2068560"/>
            <a:ext cx="446040" cy="22860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69" name="Object 82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1568520" y="2068560"/>
                      <a:ext cx="446040" cy="228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0" name="Object 83"/>
            <p:cNvGraphicFramePr/>
            <p:nvPr/>
          </p:nvGraphicFramePr>
          <p:xfrm>
            <a:off x="2011320" y="2068560"/>
            <a:ext cx="193680" cy="22860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71" name="Object 83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2011320" y="2068560"/>
                      <a:ext cx="193680" cy="228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2" name="Object 84"/>
            <p:cNvGraphicFramePr/>
            <p:nvPr/>
          </p:nvGraphicFramePr>
          <p:xfrm>
            <a:off x="2376360" y="2065320"/>
            <a:ext cx="190440" cy="23652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73" name="Object 84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2376360" y="2065320"/>
                      <a:ext cx="190440" cy="23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4" name="Object 85"/>
            <p:cNvGraphicFramePr/>
            <p:nvPr/>
          </p:nvGraphicFramePr>
          <p:xfrm>
            <a:off x="2198520" y="2068560"/>
            <a:ext cx="182520" cy="22860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75" name="Object 85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2198520" y="2068560"/>
                      <a:ext cx="182520" cy="228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6" name=""/>
            <p:cNvSpPr/>
            <p:nvPr/>
          </p:nvSpPr>
          <p:spPr>
            <a:xfrm>
              <a:off x="1577880" y="2065320"/>
              <a:ext cx="1005120" cy="228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Text Box 35"/>
          <p:cNvSpPr/>
          <p:nvPr/>
        </p:nvSpPr>
        <p:spPr>
          <a:xfrm rot="16200000">
            <a:off x="1395360" y="107928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6"/>
          <p:cNvSpPr/>
          <p:nvPr/>
        </p:nvSpPr>
        <p:spPr>
          <a:xfrm rot="16200000">
            <a:off x="1568160" y="106776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om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37"/>
          <p:cNvSpPr/>
          <p:nvPr/>
        </p:nvSpPr>
        <p:spPr>
          <a:xfrm rot="16200000">
            <a:off x="1784520" y="1058760"/>
            <a:ext cx="62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G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38"/>
          <p:cNvSpPr/>
          <p:nvPr/>
        </p:nvSpPr>
        <p:spPr>
          <a:xfrm rot="16200000">
            <a:off x="1843920" y="918360"/>
            <a:ext cx="90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+EG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9"/>
          <p:cNvSpPr/>
          <p:nvPr/>
        </p:nvSpPr>
        <p:spPr>
          <a:xfrm rot="16200000">
            <a:off x="2185920" y="105336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2633400" y="218592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797200" y="204156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ree prob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633760" y="1455840"/>
            <a:ext cx="73080" cy="144360"/>
          </a:xfrm>
          <a:custGeom>
            <a:avLst/>
            <a:gdLst>
              <a:gd name="textAreaLeft" fmla="*/ 0 w 73080"/>
              <a:gd name="textAreaRight" fmla="*/ 26280 w 73080"/>
              <a:gd name="textAreaTop" fmla="*/ 3600 h 144360"/>
              <a:gd name="textAreaBottom" fmla="*/ 140760 h 14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2734920" y="1523880"/>
            <a:ext cx="142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816280" y="13795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P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633760" y="1652760"/>
            <a:ext cx="73080" cy="244440"/>
          </a:xfrm>
          <a:custGeom>
            <a:avLst/>
            <a:gdLst>
              <a:gd name="textAreaLeft" fmla="*/ 0 w 73080"/>
              <a:gd name="textAreaRight" fmla="*/ 26280 w 73080"/>
              <a:gd name="textAreaTop" fmla="*/ 6120 h 244440"/>
              <a:gd name="textAreaBottom" fmla="*/ 238320 h 24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H="1">
            <a:off x="2734920" y="1766880"/>
            <a:ext cx="142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816280" y="16225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95360" y="2282760"/>
            <a:ext cx="107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-152 to -13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550520" y="2282040"/>
            <a:ext cx="108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-190 to -171)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2560" y="258300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3" descr="G:\PhD lab backup 11.12.08\PhD\uPARNEU\Promoter\EMSA\A549 - supershift\sp-supershift, gel1, 12h märz09.tif"/>
          <p:cNvPicPr/>
          <p:nvPr/>
        </p:nvPicPr>
        <p:blipFill>
          <a:blip r:embed="rId21"/>
          <a:srcRect l="7063" t="0" r="8457" b="68049"/>
          <a:stretch/>
        </p:blipFill>
        <p:spPr>
          <a:xfrm>
            <a:off x="355680" y="3218040"/>
            <a:ext cx="1728720" cy="649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4" name="Text Box 10"/>
          <p:cNvSpPr/>
          <p:nvPr/>
        </p:nvSpPr>
        <p:spPr>
          <a:xfrm>
            <a:off x="471600" y="419724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2"/>
          <p:cNvSpPr/>
          <p:nvPr/>
        </p:nvSpPr>
        <p:spPr>
          <a:xfrm>
            <a:off x="1415880" y="4189320"/>
            <a:ext cx="5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Gerade Verbindung 45"/>
          <p:cNvSpPr/>
          <p:nvPr/>
        </p:nvSpPr>
        <p:spPr>
          <a:xfrm>
            <a:off x="417600" y="4246560"/>
            <a:ext cx="731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7"/>
          <p:cNvSpPr/>
          <p:nvPr/>
        </p:nvSpPr>
        <p:spPr>
          <a:xfrm rot="16200000">
            <a:off x="20520" y="2715480"/>
            <a:ext cx="83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 A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8"/>
          <p:cNvSpPr/>
          <p:nvPr/>
        </p:nvSpPr>
        <p:spPr>
          <a:xfrm rot="16200000">
            <a:off x="187200" y="2696400"/>
            <a:ext cx="85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om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9"/>
          <p:cNvSpPr/>
          <p:nvPr/>
        </p:nvSpPr>
        <p:spPr>
          <a:xfrm rot="16200000">
            <a:off x="500760" y="27990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1"/>
          <p:cNvSpPr/>
          <p:nvPr/>
        </p:nvSpPr>
        <p:spPr>
          <a:xfrm rot="16200000">
            <a:off x="876960" y="27972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2"/>
          <p:cNvSpPr/>
          <p:nvPr/>
        </p:nvSpPr>
        <p:spPr>
          <a:xfrm rot="16200000">
            <a:off x="1010520" y="273276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 A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23"/>
          <p:cNvSpPr/>
          <p:nvPr/>
        </p:nvSpPr>
        <p:spPr>
          <a:xfrm rot="16200000">
            <a:off x="1259640" y="27846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24"/>
          <p:cNvSpPr/>
          <p:nvPr/>
        </p:nvSpPr>
        <p:spPr>
          <a:xfrm rot="16200000">
            <a:off x="1467720" y="27846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5"/>
          <p:cNvSpPr/>
          <p:nvPr/>
        </p:nvSpPr>
        <p:spPr>
          <a:xfrm rot="16200000">
            <a:off x="1648440" y="27846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20"/>
          <p:cNvSpPr/>
          <p:nvPr/>
        </p:nvSpPr>
        <p:spPr>
          <a:xfrm rot="16200000">
            <a:off x="689760" y="279720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Picture 3" descr="G:\PhD lab backup 11.12.08\PhD\uPARNEU\Promoter\EMSA\A549 - supershift\sp-supershift, gel1, 12h märz09.tif"/>
          <p:cNvPicPr/>
          <p:nvPr/>
        </p:nvPicPr>
        <p:blipFill>
          <a:blip r:embed="rId22"/>
          <a:srcRect l="7055" t="75511" r="8528" b="10250"/>
          <a:stretch/>
        </p:blipFill>
        <p:spPr>
          <a:xfrm>
            <a:off x="355680" y="3914640"/>
            <a:ext cx="1728720" cy="289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7" name=""/>
          <p:cNvSpPr/>
          <p:nvPr/>
        </p:nvSpPr>
        <p:spPr>
          <a:xfrm flipH="1">
            <a:off x="2098440" y="405936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255760" y="391320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ree prob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H="1">
            <a:off x="2098440" y="371808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H="1">
            <a:off x="2098440" y="353520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251080" y="33861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251080" y="3573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Gerade Verbindung 45"/>
          <p:cNvSpPr/>
          <p:nvPr/>
        </p:nvSpPr>
        <p:spPr>
          <a:xfrm>
            <a:off x="1390680" y="4246560"/>
            <a:ext cx="639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17"/>
          <p:cNvSpPr/>
          <p:nvPr/>
        </p:nvSpPr>
        <p:spPr>
          <a:xfrm rot="16200000">
            <a:off x="3537000" y="2785320"/>
            <a:ext cx="69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Jun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19"/>
          <p:cNvSpPr/>
          <p:nvPr/>
        </p:nvSpPr>
        <p:spPr>
          <a:xfrm rot="16200000">
            <a:off x="3624840" y="274644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Jun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21"/>
          <p:cNvSpPr/>
          <p:nvPr/>
        </p:nvSpPr>
        <p:spPr>
          <a:xfrm rot="16200000">
            <a:off x="3744720" y="2747160"/>
            <a:ext cx="79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-F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23"/>
          <p:cNvSpPr/>
          <p:nvPr/>
        </p:nvSpPr>
        <p:spPr>
          <a:xfrm rot="16200000">
            <a:off x="3906720" y="2737800"/>
            <a:ext cx="79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os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25"/>
          <p:cNvSpPr/>
          <p:nvPr/>
        </p:nvSpPr>
        <p:spPr>
          <a:xfrm rot="16200000">
            <a:off x="4054680" y="277488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ra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27"/>
          <p:cNvSpPr/>
          <p:nvPr/>
        </p:nvSpPr>
        <p:spPr>
          <a:xfrm rot="16200000">
            <a:off x="4195080" y="27709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ra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28"/>
          <p:cNvSpPr/>
          <p:nvPr/>
        </p:nvSpPr>
        <p:spPr>
          <a:xfrm rot="16200000">
            <a:off x="4337280" y="277632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35"/>
          <p:cNvSpPr/>
          <p:nvPr/>
        </p:nvSpPr>
        <p:spPr>
          <a:xfrm rot="16200000">
            <a:off x="3118680" y="2787840"/>
            <a:ext cx="69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 A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36"/>
          <p:cNvSpPr/>
          <p:nvPr/>
        </p:nvSpPr>
        <p:spPr>
          <a:xfrm rot="16200000">
            <a:off x="3273480" y="2822400"/>
            <a:ext cx="66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om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36"/>
          <p:cNvSpPr/>
          <p:nvPr/>
        </p:nvSpPr>
        <p:spPr>
          <a:xfrm rot="16200000">
            <a:off x="3337560" y="2741760"/>
            <a:ext cx="77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-c-Ju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feld 63"/>
          <p:cNvSpPr/>
          <p:nvPr/>
        </p:nvSpPr>
        <p:spPr>
          <a:xfrm>
            <a:off x="3882960" y="4159080"/>
            <a:ext cx="6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feld 63"/>
          <p:cNvSpPr/>
          <p:nvPr/>
        </p:nvSpPr>
        <p:spPr>
          <a:xfrm>
            <a:off x="5184720" y="4145040"/>
            <a:ext cx="49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2" descr="G:\2GB stick 23.04.2009\PhD ab 11.12.08\uPARNEU\Promoter\EMSA\A549 - supershift\ap-supershift, gel3, 24h märz09.tif"/>
          <p:cNvPicPr/>
          <p:nvPr/>
        </p:nvPicPr>
        <p:blipFill>
          <a:blip r:embed="rId23"/>
          <a:srcRect l="27532" t="0" r="0" b="71186"/>
          <a:stretch/>
        </p:blipFill>
        <p:spPr>
          <a:xfrm>
            <a:off x="3639960" y="3222720"/>
            <a:ext cx="1195560" cy="57132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2" descr="G:\2GB stick 23.04.2009\PhD ab 11.12.08\uPARNEU\Promoter\EMSA\A549 - supershift\ap-supershift, gel3, 24h märz09.tif"/>
          <p:cNvPicPr/>
          <p:nvPr/>
        </p:nvPicPr>
        <p:blipFill>
          <a:blip r:embed="rId24"/>
          <a:srcRect l="0" t="0" r="79603" b="71660"/>
          <a:stretch/>
        </p:blipFill>
        <p:spPr>
          <a:xfrm>
            <a:off x="3344760" y="3232080"/>
            <a:ext cx="336600" cy="56196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3" descr="G:\2GB stick 23.04.2009\PhD ab 11.12.08\uPARNEU\Promoter\EMSA\A549 - supershift\ap-supershift, gel4, 24h märz09.tif"/>
          <p:cNvPicPr/>
          <p:nvPr/>
        </p:nvPicPr>
        <p:blipFill>
          <a:blip r:embed="rId25"/>
          <a:srcRect l="18556" t="0" r="6153" b="72072"/>
          <a:stretch/>
        </p:blipFill>
        <p:spPr>
          <a:xfrm>
            <a:off x="4819680" y="3241800"/>
            <a:ext cx="1224000" cy="552240"/>
          </a:xfrm>
          <a:prstGeom prst="rect">
            <a:avLst/>
          </a:prstGeom>
          <a:ln w="0">
            <a:noFill/>
          </a:ln>
        </p:spPr>
      </p:pic>
      <p:cxnSp>
        <p:nvCxnSpPr>
          <p:cNvPr id="129" name="Gerade Verbindung mit Pfeil 73"/>
          <p:cNvCxnSpPr/>
          <p:nvPr/>
        </p:nvCxnSpPr>
        <p:spPr>
          <a:xfrm>
            <a:off x="3583080" y="3370320"/>
            <a:ext cx="78480" cy="30600"/>
          </a:xfrm>
          <a:prstGeom prst="straightConnector1">
            <a:avLst/>
          </a:prstGeom>
          <a:ln w="0">
            <a:noFill/>
          </a:ln>
        </p:spPr>
      </p:cxnSp>
      <p:cxnSp>
        <p:nvCxnSpPr>
          <p:cNvPr id="130" name="Gerade Verbindung mit Pfeil 74"/>
          <p:cNvCxnSpPr/>
          <p:nvPr/>
        </p:nvCxnSpPr>
        <p:spPr>
          <a:xfrm>
            <a:off x="5189400" y="3376440"/>
            <a:ext cx="78480" cy="30600"/>
          </a:xfrm>
          <a:prstGeom prst="straightConnector1">
            <a:avLst/>
          </a:prstGeom>
          <a:ln w="0">
            <a:noFill/>
          </a:ln>
        </p:spPr>
      </p:cxnSp>
      <p:pic>
        <p:nvPicPr>
          <p:cNvPr id="131" name="Picture 2" descr="G:\2GB stick 23.04.2009\PhD ab 11.12.08\uPARNEU\Promoter\EMSA\A549 - supershift\ap-supershift, gel3, 24h märz09.tif"/>
          <p:cNvPicPr/>
          <p:nvPr/>
        </p:nvPicPr>
        <p:blipFill>
          <a:blip r:embed="rId26"/>
          <a:srcRect l="27532" t="76147" r="0" b="9368"/>
          <a:stretch/>
        </p:blipFill>
        <p:spPr>
          <a:xfrm>
            <a:off x="3651120" y="3875040"/>
            <a:ext cx="1195560" cy="27000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2" descr="G:\2GB stick 23.04.2009\PhD ab 11.12.08\uPARNEU\Promoter\EMSA\A549 - supershift\ap-supershift, gel3, 24h märz09.tif"/>
          <p:cNvPicPr/>
          <p:nvPr/>
        </p:nvPicPr>
        <p:blipFill>
          <a:blip r:embed="rId27"/>
          <a:srcRect l="0" t="75667" r="82490" b="9848"/>
          <a:stretch/>
        </p:blipFill>
        <p:spPr>
          <a:xfrm>
            <a:off x="3365640" y="3875040"/>
            <a:ext cx="288720" cy="27000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3" descr="G:\2GB stick 23.04.2009\PhD ab 11.12.08\uPARNEU\Promoter\EMSA\A549 - supershift\ap-supershift, gel4, 24h märz09.tif"/>
          <p:cNvPicPr/>
          <p:nvPr/>
        </p:nvPicPr>
        <p:blipFill>
          <a:blip r:embed="rId28"/>
          <a:srcRect l="17697" t="74326" r="2441" b="11157"/>
          <a:stretch/>
        </p:blipFill>
        <p:spPr>
          <a:xfrm>
            <a:off x="4819680" y="3875040"/>
            <a:ext cx="1276200" cy="27000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3341520" y="3227400"/>
            <a:ext cx="2716560" cy="576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7"/>
          <p:cNvSpPr/>
          <p:nvPr/>
        </p:nvSpPr>
        <p:spPr>
          <a:xfrm rot="16200000">
            <a:off x="4787640" y="2785320"/>
            <a:ext cx="69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Jun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9"/>
          <p:cNvSpPr/>
          <p:nvPr/>
        </p:nvSpPr>
        <p:spPr>
          <a:xfrm rot="16200000">
            <a:off x="4866480" y="274644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Jun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21"/>
          <p:cNvSpPr/>
          <p:nvPr/>
        </p:nvSpPr>
        <p:spPr>
          <a:xfrm rot="16200000">
            <a:off x="4992480" y="2742480"/>
            <a:ext cx="79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-F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23"/>
          <p:cNvSpPr/>
          <p:nvPr/>
        </p:nvSpPr>
        <p:spPr>
          <a:xfrm rot="16200000">
            <a:off x="5133960" y="2747160"/>
            <a:ext cx="79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os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25"/>
          <p:cNvSpPr/>
          <p:nvPr/>
        </p:nvSpPr>
        <p:spPr>
          <a:xfrm rot="16200000">
            <a:off x="5276880" y="279072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ra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27"/>
          <p:cNvSpPr/>
          <p:nvPr/>
        </p:nvSpPr>
        <p:spPr>
          <a:xfrm rot="16200000">
            <a:off x="5398200" y="277992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ra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28"/>
          <p:cNvSpPr/>
          <p:nvPr/>
        </p:nvSpPr>
        <p:spPr>
          <a:xfrm rot="16200000">
            <a:off x="5550120" y="278604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36"/>
          <p:cNvSpPr/>
          <p:nvPr/>
        </p:nvSpPr>
        <p:spPr>
          <a:xfrm rot="16200000">
            <a:off x="4600080" y="2756520"/>
            <a:ext cx="76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-c-Ju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5"/>
          <p:cNvSpPr/>
          <p:nvPr/>
        </p:nvSpPr>
        <p:spPr>
          <a:xfrm rot="16200000">
            <a:off x="4528440" y="2797200"/>
            <a:ext cx="69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 A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346560" y="3855960"/>
            <a:ext cx="2711520" cy="28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106800" y="402588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Gerade Verbindung 45"/>
          <p:cNvSpPr/>
          <p:nvPr/>
        </p:nvSpPr>
        <p:spPr>
          <a:xfrm>
            <a:off x="3371760" y="4197240"/>
            <a:ext cx="1366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Gerade Verbindung 45"/>
          <p:cNvSpPr/>
          <p:nvPr/>
        </p:nvSpPr>
        <p:spPr>
          <a:xfrm>
            <a:off x="4867200" y="4197240"/>
            <a:ext cx="1096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198960" y="3284640"/>
            <a:ext cx="72720" cy="431640"/>
          </a:xfrm>
          <a:custGeom>
            <a:avLst/>
            <a:gdLst>
              <a:gd name="textAreaLeft" fmla="*/ 46440 w 72720"/>
              <a:gd name="textAreaRight" fmla="*/ 73080 w 72720"/>
              <a:gd name="textAreaTop" fmla="*/ 11160 h 431640"/>
              <a:gd name="textAreaBottom" fmla="*/ 420480 h 431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987640" y="3500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567160" y="33591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P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3610080" y="3462480"/>
            <a:ext cx="71280" cy="72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4878360" y="3449160"/>
            <a:ext cx="71640" cy="73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662040" y="3509640"/>
            <a:ext cx="71280" cy="73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1449360" y="3497400"/>
            <a:ext cx="71640" cy="72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878040" y="3712680"/>
            <a:ext cx="71280" cy="73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1631880" y="3708000"/>
            <a:ext cx="71640" cy="73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7520" y="438300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8" name=""/>
          <p:cNvGrpSpPr/>
          <p:nvPr/>
        </p:nvGrpSpPr>
        <p:grpSpPr>
          <a:xfrm>
            <a:off x="130320" y="4664160"/>
            <a:ext cx="2946240" cy="2087640"/>
            <a:chOff x="130320" y="4664160"/>
            <a:chExt cx="2946240" cy="2087640"/>
          </a:xfrm>
        </p:grpSpPr>
        <p:sp>
          <p:nvSpPr>
            <p:cNvPr id="159" name=""/>
            <p:cNvSpPr/>
            <p:nvPr/>
          </p:nvSpPr>
          <p:spPr>
            <a:xfrm>
              <a:off x="255600" y="4886280"/>
              <a:ext cx="2592360" cy="71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797040" y="4886280"/>
              <a:ext cx="539640" cy="7164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731960" y="4883040"/>
              <a:ext cx="53964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292400" y="6275520"/>
              <a:ext cx="539640" cy="71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300320" y="5627520"/>
              <a:ext cx="53964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716200" y="466560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30320" y="466416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4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693720" y="4925880"/>
              <a:ext cx="86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AP-1 Region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190 to -17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662120" y="4925880"/>
              <a:ext cx="851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Sp1 Region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152 to -13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63400" y="5699160"/>
              <a:ext cx="208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50800" y="6346800"/>
              <a:ext cx="208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271600" y="5672160"/>
              <a:ext cx="216000" cy="28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360" bIns="-183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2206800" y="6313320"/>
              <a:ext cx="215640" cy="28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687240" y="6313320"/>
              <a:ext cx="216000" cy="28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760320" y="5672160"/>
              <a:ext cx="216000" cy="28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360" bIns="-183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760320" y="560880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687240" y="626256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H="1">
              <a:off x="2246040" y="561492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H="1">
              <a:off x="2181240" y="625644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399960" y="5651640"/>
              <a:ext cx="901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Forward Primer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231 to -21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911240" y="5646600"/>
              <a:ext cx="90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Reverse primer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84 to -4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399960" y="6292800"/>
              <a:ext cx="901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Forward Primer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249 to -22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911240" y="6288120"/>
              <a:ext cx="90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Reverse primer</a:t>
              </a:r>
              <a:br>
                <a:rPr sz="800"/>
              </a:b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-162 to -14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349280" y="5378400"/>
              <a:ext cx="43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S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317600" y="6033960"/>
              <a:ext cx="561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4" name=""/>
          <p:cNvSpPr/>
          <p:nvPr/>
        </p:nvSpPr>
        <p:spPr>
          <a:xfrm>
            <a:off x="3062160" y="258120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3T11:42:16Z</dcterms:created>
  <dc:creator>Mudduluru</dc:creator>
  <dc:description/>
  <dc:language>en-US</dc:language>
  <cp:lastModifiedBy>Giri</cp:lastModifiedBy>
  <dcterms:modified xsi:type="dcterms:W3CDTF">2010-05-02T11:34:55Z</dcterms:modified>
  <cp:revision>101</cp:revision>
  <dc:subject/>
  <dc:title>Folie 1</dc:title>
</cp:coreProperties>
</file>